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965A6-6460-48B3-A876-2F473F072951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887746-08A2-4393-8041-241A3632AAB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23242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8D391-82FA-4D3C-9B6D-3E992B7EE6F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6491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0649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294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354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2746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564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1017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7173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9576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965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4441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1960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382C6-3239-489D-ABB5-4DFA05466223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3608C-3B74-41B7-B153-5B47D6B068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79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" name="Tabelle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2216371"/>
              </p:ext>
            </p:extLst>
          </p:nvPr>
        </p:nvGraphicFramePr>
        <p:xfrm>
          <a:off x="683568" y="1628800"/>
          <a:ext cx="1803400" cy="4371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4400"/>
                <a:gridCol w="889000"/>
              </a:tblGrid>
              <a:tr h="48577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Serum MMP-2 </a:t>
                      </a:r>
                      <a:r>
                        <a:rPr lang="de-DE" sz="1000" u="none" strike="noStrike" dirty="0" err="1">
                          <a:effectLst/>
                        </a:rPr>
                        <a:t>patients</a:t>
                      </a:r>
                      <a:r>
                        <a:rPr lang="de-DE" sz="1000" u="none" strike="noStrike" dirty="0">
                          <a:effectLst/>
                        </a:rPr>
                        <a:t> [</a:t>
                      </a:r>
                      <a:r>
                        <a:rPr lang="de-DE" sz="1000" u="none" strike="noStrike" dirty="0" err="1">
                          <a:effectLst/>
                        </a:rPr>
                        <a:t>ng</a:t>
                      </a:r>
                      <a:r>
                        <a:rPr lang="de-DE" sz="1000" u="none" strike="noStrike" dirty="0">
                          <a:effectLst/>
                        </a:rPr>
                        <a:t>/ml]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Serum MMP-2 </a:t>
                      </a:r>
                      <a:r>
                        <a:rPr lang="de-DE" sz="1000" u="none" strike="noStrike" dirty="0" err="1">
                          <a:effectLst/>
                        </a:rPr>
                        <a:t>controls</a:t>
                      </a:r>
                      <a:r>
                        <a:rPr lang="de-DE" sz="1000" u="none" strike="noStrike" dirty="0">
                          <a:effectLst/>
                        </a:rPr>
                        <a:t> [</a:t>
                      </a:r>
                      <a:r>
                        <a:rPr lang="de-DE" sz="1000" u="none" strike="noStrike" dirty="0" err="1">
                          <a:effectLst/>
                        </a:rPr>
                        <a:t>ng</a:t>
                      </a:r>
                      <a:r>
                        <a:rPr lang="de-DE" sz="1000" u="none" strike="noStrike" dirty="0">
                          <a:effectLst/>
                        </a:rPr>
                        <a:t>/ml]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39.5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99.7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5.6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9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99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65.7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9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16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94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3.5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5.7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77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15.2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14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97.6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58.3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3.9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11.1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49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17.3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6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07.0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32.1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14.3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30.0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1.2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6.1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76.3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7.4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71.7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4.1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78.4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94.5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4.2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78.5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54.8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1.3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84.6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1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81.7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33.6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78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9.4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52" name="Rechteck 51"/>
          <p:cNvSpPr/>
          <p:nvPr/>
        </p:nvSpPr>
        <p:spPr>
          <a:xfrm>
            <a:off x="686768" y="528167"/>
            <a:ext cx="263691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 Table. </a:t>
            </a:r>
            <a:endParaRPr lang="de-DE" sz="1000" b="1" dirty="0" smtClean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um MMP-2 in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endParaRPr lang="de-DE" sz="1000" b="1" dirty="0" smtClean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um MMP-2 was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nzyme-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k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sorbent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ssay</a:t>
            </a:r>
            <a:endParaRPr lang="de-DE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259798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Bildschirmpräsentation (4:3)</PresentationFormat>
  <Paragraphs>49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10:04Z</dcterms:created>
  <dcterms:modified xsi:type="dcterms:W3CDTF">2016-09-29T14:10:24Z</dcterms:modified>
</cp:coreProperties>
</file>